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7B8B9A-482B-4F9E-A1CF-8F514730BB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89F02F-F01C-47A2-A596-AFF03A10E0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4DA879-F509-4349-9452-066A42DE7D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92ABA1-1061-404A-AEEB-08CFA6E86C2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F8A9FA-72FD-4499-B0A1-A963F8CA39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BD7661-7718-4AC2-B446-FF00A4017D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18631A-221F-4226-B6BA-FDCCD88686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CBB402-E3F4-43B8-8623-B9F71D4940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771F91-2A37-4C44-8CC2-29CAD51EDC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A3EB5E-D2A2-46C6-ABFB-646F341EA3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358848-DAE0-4988-AB35-DCD5BAD031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87EE37-1042-4B6E-83AA-719643BB19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D6093B-7DD1-4BE1-9868-41F37D6C63E1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age 1" descr="Echo rein post natal Mateo Kal1 Julie  huta résolution.jpg"/>
          <p:cNvPicPr/>
          <p:nvPr/>
        </p:nvPicPr>
        <p:blipFill>
          <a:blip r:embed="rId1"/>
          <a:srcRect l="5214" t="3259" r="60193" b="76454"/>
          <a:stretch/>
        </p:blipFill>
        <p:spPr>
          <a:xfrm>
            <a:off x="284040" y="1268280"/>
            <a:ext cx="4143600" cy="3024360"/>
          </a:xfrm>
          <a:prstGeom prst="rect">
            <a:avLst/>
          </a:prstGeom>
          <a:ln w="0">
            <a:noFill/>
          </a:ln>
        </p:spPr>
      </p:pic>
      <p:sp>
        <p:nvSpPr>
          <p:cNvPr id="42" name="Text Box 7"/>
          <p:cNvSpPr/>
          <p:nvPr/>
        </p:nvSpPr>
        <p:spPr>
          <a:xfrm>
            <a:off x="2700360" y="234936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ffffff"/>
                </a:solidFill>
                <a:latin typeface="Arial"/>
              </a:rPr>
              <a:t>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9" descr=""/>
          <p:cNvPicPr/>
          <p:nvPr/>
        </p:nvPicPr>
        <p:blipFill>
          <a:blip r:embed="rId2"/>
          <a:stretch/>
        </p:blipFill>
        <p:spPr>
          <a:xfrm rot="16200000">
            <a:off x="5199480" y="640080"/>
            <a:ext cx="3030840" cy="4286160"/>
          </a:xfrm>
          <a:prstGeom prst="rect">
            <a:avLst/>
          </a:prstGeom>
          <a:ln w="0">
            <a:noFill/>
          </a:ln>
        </p:spPr>
      </p:pic>
      <p:sp>
        <p:nvSpPr>
          <p:cNvPr id="44" name="Line 5"/>
          <p:cNvSpPr/>
          <p:nvPr/>
        </p:nvSpPr>
        <p:spPr>
          <a:xfrm flipV="1">
            <a:off x="5796000" y="2492280"/>
            <a:ext cx="1944720" cy="144720"/>
          </a:xfrm>
          <a:prstGeom prst="line">
            <a:avLst/>
          </a:prstGeom>
          <a:ln w="25560">
            <a:solidFill>
              <a:srgbClr val="ffffff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8"/>
          <p:cNvSpPr/>
          <p:nvPr/>
        </p:nvSpPr>
        <p:spPr>
          <a:xfrm>
            <a:off x="250920" y="1268280"/>
            <a:ext cx="28872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8"/>
          <p:cNvSpPr/>
          <p:nvPr/>
        </p:nvSpPr>
        <p:spPr>
          <a:xfrm>
            <a:off x="4572000" y="1268280"/>
            <a:ext cx="28908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ZoneTexte 2"/>
          <p:cNvSpPr/>
          <p:nvPr/>
        </p:nvSpPr>
        <p:spPr>
          <a:xfrm>
            <a:off x="6890400" y="115920"/>
            <a:ext cx="21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Supplemental Fig.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ZoneTexte 1"/>
          <p:cNvSpPr/>
          <p:nvPr/>
        </p:nvSpPr>
        <p:spPr>
          <a:xfrm>
            <a:off x="352440" y="3789360"/>
            <a:ext cx="11131560" cy="287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 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5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Times New Roman"/>
                <a:ea typeface="Calibri"/>
              </a:rPr>
              <a:t>Supplemental Figure 1 : Post-natal kidney ultrasound  performed in the neonate carrying th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5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Times New Roman"/>
                <a:ea typeface="Calibri"/>
              </a:rPr>
              <a:t>p.R257X </a:t>
            </a:r>
            <a:r>
              <a:rPr b="1" i="1" lang="fr-FR" sz="1600" spc="-1" strike="noStrike">
                <a:solidFill>
                  <a:srgbClr val="000000"/>
                </a:solidFill>
                <a:latin typeface="Times New Roman"/>
                <a:ea typeface="Calibri"/>
              </a:rPr>
              <a:t>KAL1 </a:t>
            </a:r>
            <a:r>
              <a:rPr b="1" lang="fr-FR" sz="1600" spc="-1" strike="noStrike">
                <a:solidFill>
                  <a:srgbClr val="000000"/>
                </a:solidFill>
                <a:latin typeface="Times New Roman"/>
                <a:ea typeface="Calibri"/>
              </a:rPr>
              <a:t>mutation (see also Fig.3)</a:t>
            </a:r>
            <a:r>
              <a:rPr b="0" lang="fr-FR" sz="1600" spc="-1" strike="noStrike">
                <a:solidFill>
                  <a:srgbClr val="000000"/>
                </a:solidFill>
                <a:latin typeface="Calibri"/>
                <a:ea typeface="Calibri"/>
              </a:rPr>
              <a:t>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5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Times New Roman"/>
                <a:ea typeface="Calibri"/>
              </a:rPr>
              <a:t>Panel A : </a:t>
            </a:r>
            <a:r>
              <a:rPr b="0" lang="fr-FR" sz="1600" spc="-1" strike="noStrike">
                <a:solidFill>
                  <a:srgbClr val="000000"/>
                </a:solidFill>
                <a:latin typeface="Times New Roman"/>
                <a:ea typeface="Calibri"/>
              </a:rPr>
              <a:t>Left posterior fossa view showing the absent left kidney. S : spleen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5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Times New Roman"/>
                <a:ea typeface="Calibri"/>
              </a:rPr>
              <a:t>Panel B :</a:t>
            </a:r>
            <a:r>
              <a:rPr b="0" lang="fr-FR" sz="1600" spc="-1" strike="noStrike">
                <a:solidFill>
                  <a:srgbClr val="000000"/>
                </a:solidFill>
                <a:latin typeface="Times New Roman"/>
                <a:ea typeface="Calibri"/>
              </a:rPr>
              <a:t> Right kidney ultrasound revealing compensatory hypertrophy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5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Times New Roman"/>
                <a:ea typeface="Calibri"/>
              </a:rPr>
              <a:t>(dotted line indicate kidney length (65 mm)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2-10T15:46:43Z</dcterms:created>
  <dc:creator>CHU BICETRE</dc:creator>
  <dc:description/>
  <dc:language>en-US</dc:language>
  <cp:lastModifiedBy>Jacques Young</cp:lastModifiedBy>
  <dcterms:modified xsi:type="dcterms:W3CDTF">2015-02-13T20:17:39Z</dcterms:modified>
  <cp:revision>18</cp:revision>
  <dc:subject/>
  <dc:title>Diapositive 1</dc:title>
</cp:coreProperties>
</file>